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75B8C-82C5-4FE1-941B-CB6EB89F46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DD91F4-7537-4909-BB9D-C40655CA09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FC917-A0B0-4A1C-9559-20A222B6AB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DF06A5-8FD7-4AEF-82BA-FCF4BE48FA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C058D-CC5C-4C23-8B17-55F7413F51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B5A34-6225-463E-9774-2F65F3A00D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65E39C-63A5-4B85-B278-3B16DF3A2A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22726-36DF-4E6F-A385-E065FDD8E0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9D7D24-C70E-41D9-AC18-16AA1794CA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9F0C75-A20A-4AA7-98E4-B8F6EABB25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CEE70-B3E4-4EFF-B67E-A8CFD71071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33613-CB53-4825-A0D9-B7049C0C68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305AB3-E692-4E46-9C7F-EF5E1F146D2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11280" y="189000"/>
            <a:ext cx="8424720" cy="64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3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GCACGTTCAAGGAGGCCAATGCGGTAACCAAA</a:t>
            </a:r>
            <a:r>
              <a:rPr b="0" lang="en-US" sz="2200" spc="-1" strike="noStrike">
                <a:solidFill>
                  <a:srgbClr val="ff0000"/>
                </a:solidFill>
                <a:latin typeface="Arial"/>
              </a:rPr>
              <a:t>TCGGTTCCAAATTCTGGGAAGTT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ATCTGCGACAAACACGGCATCGATACAACCGGAAAGTACATCGGCGACGGTAGCGGTTCCGATCTACAACTCGAACGAATCATTGTCTATTACAACGACCCCTCTGGTGGAAAATATGTTCCTAGAGCGGTTCTCATGGATCTTGAACCTGGAACCATGGATAGCATTATATCTGGACCGTACGGCAAGATCTTCCGACCTGATAACTTCGTGTTCGGTCAATCTGGTGCGGGGAATAACTGGGCGAAAGGTCATTATACTGAAGGTGCTGAGTTGATTGATTCTGTTCTCGATGTCGTTCGAAAAGAGGATGAGAACTGTGATTGCTTGCAAGGTTTCCAAGTTTGTCCCTCA</a:t>
            </a:r>
            <a:r>
              <a:rPr b="0" lang="en-US" sz="2200" spc="-1" strike="noStrike">
                <a:solidFill>
                  <a:srgbClr val="ff0000"/>
                </a:solidFill>
                <a:latin typeface="Arial"/>
              </a:rPr>
              <a:t>CTTGGAGGAGGCACTGGTTC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TGGCGTGGCAACATTATTGATATCAAAGATCAGGGAGAAATACCCTGACAGGATGATGCTTACTTTTCTCTGTTTTCCCCTTCTCCAAGGGTCTCTGACCAGTGGTGAACCCATACATGCCTTTTTATCTGTGCACCAGCTTGTAAAAGAATGCTGAATGAGTGCTTGGTTCTCGACAACAAACCACTTTATAGACTTTTGCTTTCTGATCTTTAAACCCACCCCCTCCTAGTTGTGGACGATCCGAACCATTTTGATATCGGAACTAGGGAGGGGAGTTACCTGGTTGCTTAATGGTTTCCAGGAAAATTAGACTCTTGATCACGGGGATGTTTGGTTGGTATTTCTTGT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15T04:46:22Z</dcterms:created>
  <dc:creator>Foley, Rhonda (PI, Floreat)</dc:creator>
  <dc:description/>
  <dc:language>en-US</dc:language>
  <cp:lastModifiedBy>Foley, Rhonda (PI, Floreat)</cp:lastModifiedBy>
  <dcterms:modified xsi:type="dcterms:W3CDTF">2011-03-24T03:09:10Z</dcterms:modified>
  <cp:revision>64</cp:revision>
  <dc:subject/>
  <dc:title>Slide 1</dc:title>
</cp:coreProperties>
</file>